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0058400" cy="7772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44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594" y="-96"/>
      </p:cViewPr>
      <p:guideLst>
        <p:guide orient="horz" pos="2448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414482"/>
            <a:ext cx="8549640" cy="166602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4404360"/>
            <a:ext cx="704088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99187" y="456989"/>
            <a:ext cx="1922621" cy="972629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833" y="456989"/>
            <a:ext cx="5603716" cy="972629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4994487"/>
            <a:ext cx="8549640" cy="154368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294275"/>
            <a:ext cx="8549640" cy="17002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837" y="2659169"/>
            <a:ext cx="3763169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58640" y="2659169"/>
            <a:ext cx="3763170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739795"/>
            <a:ext cx="4444207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464859"/>
            <a:ext cx="4444207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34" y="1739795"/>
            <a:ext cx="4445953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34" y="2464859"/>
            <a:ext cx="4445953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09456"/>
            <a:ext cx="3309144" cy="13169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4" y="309457"/>
            <a:ext cx="5622926" cy="663352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0" y="1626447"/>
            <a:ext cx="3309144" cy="531653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5440680"/>
            <a:ext cx="6035040" cy="6423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694479"/>
            <a:ext cx="6035040" cy="4663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6082983"/>
            <a:ext cx="6035040" cy="91217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13565"/>
            <a:ext cx="9052560" cy="51294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7203865"/>
            <a:ext cx="31851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jpeg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72655" y="-76200"/>
            <a:ext cx="9175568" cy="6934200"/>
            <a:chOff x="-144390" y="0"/>
            <a:chExt cx="10284702" cy="7772400"/>
          </a:xfrm>
        </p:grpSpPr>
        <p:sp>
          <p:nvSpPr>
            <p:cNvPr id="72" name="TextBox 71"/>
            <p:cNvSpPr txBox="1"/>
            <p:nvPr/>
          </p:nvSpPr>
          <p:spPr>
            <a:xfrm rot="16200000">
              <a:off x="3091189" y="697367"/>
              <a:ext cx="1371600" cy="586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err="1" smtClean="0">
                  <a:solidFill>
                    <a:srgbClr val="FF00FF"/>
                  </a:solidFill>
                  <a:latin typeface="Arial" pitchFamily="34" charset="0"/>
                  <a:cs typeface="Arial" pitchFamily="34" charset="0"/>
                </a:rPr>
                <a:t>BrdU</a:t>
              </a:r>
              <a:r>
                <a:rPr lang="en-US" sz="1400" b="1" dirty="0" err="1" smtClean="0">
                  <a:solidFill>
                    <a:srgbClr val="3366FF"/>
                  </a:solidFill>
                  <a:latin typeface="Arial" pitchFamily="34" charset="0"/>
                  <a:cs typeface="Arial" pitchFamily="34" charset="0"/>
                </a:rPr>
                <a:t>DAPI</a:t>
              </a:r>
              <a:endParaRPr lang="en-US" sz="1400" b="1" dirty="0">
                <a:solidFill>
                  <a:srgbClr val="3366FF"/>
                </a:solidFill>
                <a:latin typeface="Arial" pitchFamily="34" charset="0"/>
                <a:cs typeface="Arial" pitchFamily="34" charset="0"/>
              </a:endParaRPr>
            </a:p>
            <a:p>
              <a:pPr algn="ctr"/>
              <a:endParaRPr lang="en-US" sz="14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-501604" y="2167633"/>
              <a:ext cx="1542381" cy="8279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err="1" smtClean="0">
                  <a:solidFill>
                    <a:srgbClr val="00FF00"/>
                  </a:solidFill>
                  <a:latin typeface="Arial" pitchFamily="34" charset="0"/>
                  <a:cs typeface="Arial" pitchFamily="34" charset="0"/>
                </a:rPr>
                <a:t>GFP</a:t>
              </a:r>
              <a:r>
                <a:rPr lang="en-US" sz="1400" b="1" dirty="0" err="1" smtClean="0">
                  <a:solidFill>
                    <a:srgbClr val="FF00FF"/>
                  </a:solidFill>
                  <a:latin typeface="Arial" pitchFamily="34" charset="0"/>
                  <a:cs typeface="Arial" pitchFamily="34" charset="0"/>
                </a:rPr>
                <a:t>BrdU</a:t>
              </a:r>
              <a:r>
                <a:rPr lang="en-US" sz="1400" b="1" dirty="0" err="1" smtClean="0">
                  <a:solidFill>
                    <a:srgbClr val="3366FF"/>
                  </a:solidFill>
                  <a:latin typeface="Arial" pitchFamily="34" charset="0"/>
                  <a:cs typeface="Arial" pitchFamily="34" charset="0"/>
                </a:rPr>
                <a:t>DAPI</a:t>
              </a:r>
              <a:endParaRPr lang="en-US" sz="1400" b="1" dirty="0">
                <a:solidFill>
                  <a:srgbClr val="3366FF"/>
                </a:solidFill>
                <a:latin typeface="Arial" pitchFamily="34" charset="0"/>
                <a:cs typeface="Arial" pitchFamily="34" charset="0"/>
              </a:endParaRPr>
            </a:p>
            <a:p>
              <a:pPr algn="ctr"/>
              <a:endParaRPr lang="en-US" sz="14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785777" y="1663088"/>
              <a:ext cx="568637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-506311" y="3827343"/>
              <a:ext cx="1371600" cy="344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err="1" smtClean="0">
                  <a:latin typeface="Arial" pitchFamily="34" charset="0"/>
                  <a:cs typeface="Arial" pitchFamily="34" charset="0"/>
                </a:rPr>
                <a:t>BrdU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4807689" y="1663088"/>
              <a:ext cx="740397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80A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2034902" y="1663088"/>
              <a:ext cx="770268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56R 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397230" y="1663088"/>
              <a:ext cx="781469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56Q</a:t>
              </a: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6182729" y="1663088"/>
              <a:ext cx="736761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80E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95925" y="4705549"/>
              <a:ext cx="951875" cy="3449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118A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7467601" y="1663088"/>
              <a:ext cx="914400" cy="3449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15R 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8885484" y="1663088"/>
              <a:ext cx="878453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15Q</a:t>
              </a: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1974466" y="4705549"/>
              <a:ext cx="833745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118E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6146764" y="4705549"/>
              <a:ext cx="893389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22Q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343957" y="4703566"/>
              <a:ext cx="755430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T118I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4710977" y="4705549"/>
              <a:ext cx="882187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22R</a:t>
              </a: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7137960" y="4705549"/>
              <a:ext cx="1549575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15R/K122R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8568333" y="4705549"/>
              <a:ext cx="1571979" cy="3449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K115Q/K122Q</a:t>
              </a:r>
            </a:p>
          </p:txBody>
        </p:sp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4800" y="1923382"/>
              <a:ext cx="1371600" cy="1371600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86100" y="1923382"/>
              <a:ext cx="1371600" cy="137160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4800" y="3314032"/>
              <a:ext cx="1371600" cy="137160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86100" y="3314032"/>
              <a:ext cx="1371600" cy="137160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95450" y="1923382"/>
              <a:ext cx="1371600" cy="137160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95450" y="3314032"/>
              <a:ext cx="1371600" cy="137160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476750" y="1923382"/>
              <a:ext cx="1371600" cy="137160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476750" y="3314032"/>
              <a:ext cx="1371600" cy="1371600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867400" y="1923382"/>
              <a:ext cx="1371600" cy="1371600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867400" y="3314032"/>
              <a:ext cx="1371600" cy="1371600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258050" y="1923382"/>
              <a:ext cx="1371600" cy="1371600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258050" y="3314032"/>
              <a:ext cx="1371600" cy="1371600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8648700" y="1923382"/>
              <a:ext cx="1371600" cy="1371600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8648700" y="3314032"/>
              <a:ext cx="1371600" cy="1371600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4800" y="4972050"/>
              <a:ext cx="1371600" cy="1371600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4800" y="6362701"/>
              <a:ext cx="1371600" cy="1371600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95450" y="4972050"/>
              <a:ext cx="1371600" cy="1371600"/>
            </a:xfrm>
            <a:prstGeom prst="rect">
              <a:avLst/>
            </a:prstGeom>
          </p:spPr>
        </p:pic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695450" y="6362701"/>
              <a:ext cx="1371600" cy="1371600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86100" y="4972050"/>
              <a:ext cx="1371600" cy="1371600"/>
            </a:xfrm>
            <a:prstGeom prst="rect">
              <a:avLst/>
            </a:prstGeom>
          </p:spPr>
        </p:pic>
        <p:pic>
          <p:nvPicPr>
            <p:cNvPr id="41" name="Picture 40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086100" y="6362701"/>
              <a:ext cx="1371600" cy="1371600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476750" y="4972050"/>
              <a:ext cx="1371600" cy="1371600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476750" y="6362701"/>
              <a:ext cx="1371600" cy="1371600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258050" y="4972050"/>
              <a:ext cx="1371600" cy="1371600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258050" y="6362701"/>
              <a:ext cx="1371600" cy="1371600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8648700" y="4972050"/>
              <a:ext cx="1371600" cy="1371600"/>
            </a:xfrm>
            <a:prstGeom prst="rect">
              <a:avLst/>
            </a:prstGeom>
          </p:spPr>
        </p:pic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8648700" y="6362701"/>
              <a:ext cx="1371600" cy="1371600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 flipH="1">
              <a:off x="5867400" y="4972050"/>
              <a:ext cx="1371600" cy="1371600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 flipH="1">
              <a:off x="5867400" y="6362701"/>
              <a:ext cx="1371600" cy="1371600"/>
            </a:xfrm>
            <a:prstGeom prst="rect">
              <a:avLst/>
            </a:prstGeom>
          </p:spPr>
        </p:pic>
        <p:pic>
          <p:nvPicPr>
            <p:cNvPr id="66" name="Picture 65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790950" y="304799"/>
              <a:ext cx="1371600" cy="1371600"/>
            </a:xfrm>
            <a:prstGeom prst="rect">
              <a:avLst/>
            </a:prstGeom>
          </p:spPr>
        </p:pic>
        <p:pic>
          <p:nvPicPr>
            <p:cNvPr id="67" name="Picture 66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5181600" y="304799"/>
              <a:ext cx="1371600" cy="1371600"/>
            </a:xfrm>
            <a:prstGeom prst="rect">
              <a:avLst/>
            </a:prstGeom>
          </p:spPr>
        </p:pic>
        <p:sp>
          <p:nvSpPr>
            <p:cNvPr id="70" name="Rectangle 69"/>
            <p:cNvSpPr/>
            <p:nvPr/>
          </p:nvSpPr>
          <p:spPr>
            <a:xfrm>
              <a:off x="4038601" y="0"/>
              <a:ext cx="914400" cy="3449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i="1" dirty="0" err="1" smtClean="0">
                  <a:latin typeface="Arial" pitchFamily="34" charset="0"/>
                  <a:cs typeface="Arial" pitchFamily="34" charset="0"/>
                </a:rPr>
                <a:t>yw</a:t>
              </a:r>
              <a:r>
                <a:rPr lang="en-US" sz="1400" b="1" i="1" dirty="0" smtClean="0">
                  <a:latin typeface="Arial" pitchFamily="34" charset="0"/>
                  <a:cs typeface="Arial" pitchFamily="34" charset="0"/>
                </a:rPr>
                <a:t> 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676400" y="1871246"/>
              <a:ext cx="373078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C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066120" y="1871246"/>
              <a:ext cx="373078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D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456771" y="1871246"/>
              <a:ext cx="360387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E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805510" y="1871246"/>
              <a:ext cx="347474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F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7189213" y="1871246"/>
              <a:ext cx="385879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G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8632112" y="1871246"/>
              <a:ext cx="373078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04799" y="4953000"/>
              <a:ext cx="270886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I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1676400" y="4953000"/>
              <a:ext cx="334896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J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066120" y="4953000"/>
              <a:ext cx="379478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K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456771" y="4953000"/>
              <a:ext cx="343319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L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5805510" y="4953000"/>
              <a:ext cx="398569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7189213" y="4953000"/>
              <a:ext cx="373078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N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8632112" y="4953000"/>
              <a:ext cx="385879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O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810000" y="318672"/>
              <a:ext cx="365104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A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85751" y="1871246"/>
              <a:ext cx="373078" cy="3794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B</a:t>
              </a:r>
              <a:endParaRPr lang="en-US" sz="16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1" name="Straight Arrow Connector 90"/>
            <p:cNvCxnSpPr/>
            <p:nvPr/>
          </p:nvCxnSpPr>
          <p:spPr>
            <a:xfrm flipH="1">
              <a:off x="6096000" y="904875"/>
              <a:ext cx="76200" cy="38100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 rot="16200000">
              <a:off x="-528965" y="5316993"/>
              <a:ext cx="1581149" cy="586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err="1" smtClean="0">
                  <a:solidFill>
                    <a:srgbClr val="00FF00"/>
                  </a:solidFill>
                  <a:latin typeface="Arial" pitchFamily="34" charset="0"/>
                  <a:cs typeface="Arial" pitchFamily="34" charset="0"/>
                </a:rPr>
                <a:t>GFP</a:t>
              </a:r>
              <a:r>
                <a:rPr lang="en-US" sz="1400" b="1" dirty="0" err="1" smtClean="0">
                  <a:solidFill>
                    <a:srgbClr val="FF00FF"/>
                  </a:solidFill>
                  <a:latin typeface="Arial" pitchFamily="34" charset="0"/>
                  <a:cs typeface="Arial" pitchFamily="34" charset="0"/>
                </a:rPr>
                <a:t>BrdU</a:t>
              </a:r>
              <a:r>
                <a:rPr lang="en-US" sz="1400" b="1" dirty="0" err="1" smtClean="0">
                  <a:solidFill>
                    <a:srgbClr val="3366FF"/>
                  </a:solidFill>
                  <a:latin typeface="Arial" pitchFamily="34" charset="0"/>
                  <a:cs typeface="Arial" pitchFamily="34" charset="0"/>
                </a:rPr>
                <a:t>DAPI</a:t>
              </a:r>
              <a:endParaRPr lang="en-US" sz="1400" b="1" dirty="0">
                <a:solidFill>
                  <a:srgbClr val="3366FF"/>
                </a:solidFill>
                <a:latin typeface="Arial" pitchFamily="34" charset="0"/>
                <a:cs typeface="Arial" pitchFamily="34" charset="0"/>
              </a:endParaRPr>
            </a:p>
            <a:p>
              <a:pPr algn="ctr"/>
              <a:endParaRPr lang="en-US" sz="14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 rot="16200000">
              <a:off x="-516037" y="6914109"/>
              <a:ext cx="1371600" cy="344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err="1" smtClean="0">
                  <a:latin typeface="Arial" pitchFamily="34" charset="0"/>
                  <a:cs typeface="Arial" pitchFamily="34" charset="0"/>
                </a:rPr>
                <a:t>BrdU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" name="Rectangle 2"/>
          <p:cNvSpPr/>
          <p:nvPr/>
        </p:nvSpPr>
        <p:spPr>
          <a:xfrm>
            <a:off x="2" y="152400"/>
            <a:ext cx="15824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Supplemental Figure 1</a:t>
            </a:r>
            <a:endParaRPr lang="en-US" sz="1000" dirty="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38</Words>
  <Application>Microsoft Office PowerPoint</Application>
  <PresentationFormat>Custom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illary Graves</dc:creator>
  <cp:lastModifiedBy>0002401</cp:lastModifiedBy>
  <cp:revision>28</cp:revision>
  <cp:lastPrinted>2015-11-20T14:49:24Z</cp:lastPrinted>
  <dcterms:created xsi:type="dcterms:W3CDTF">2015-10-29T21:52:50Z</dcterms:created>
  <dcterms:modified xsi:type="dcterms:W3CDTF">2016-02-22T11:47:09Z</dcterms:modified>
</cp:coreProperties>
</file>